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96" r:id="rId2"/>
    <p:sldId id="297" r:id="rId3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 varScale="1">
        <p:scale>
          <a:sx n="58" d="100"/>
          <a:sy n="58" d="100"/>
        </p:scale>
        <p:origin x="2467" y="91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origene.com/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2"/>
          <p:cNvSpPr txBox="1"/>
          <p:nvPr/>
        </p:nvSpPr>
        <p:spPr>
          <a:xfrm>
            <a:off x="-8756" y="128464"/>
            <a:ext cx="2730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sp>
        <p:nvSpPr>
          <p:cNvPr id="50" name="TextBox 4"/>
          <p:cNvSpPr txBox="1"/>
          <p:nvPr/>
        </p:nvSpPr>
        <p:spPr>
          <a:xfrm>
            <a:off x="949852" y="971655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4"/>
          <p:cNvSpPr txBox="1"/>
          <p:nvPr/>
        </p:nvSpPr>
        <p:spPr>
          <a:xfrm>
            <a:off x="949852" y="2750369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TextBox 155"/>
          <p:cNvSpPr txBox="1"/>
          <p:nvPr/>
        </p:nvSpPr>
        <p:spPr>
          <a:xfrm rot="16200000">
            <a:off x="423719" y="1818332"/>
            <a:ext cx="1354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</p:txBody>
      </p:sp>
      <p:sp>
        <p:nvSpPr>
          <p:cNvPr id="48" name="TextBox 172"/>
          <p:cNvSpPr txBox="1"/>
          <p:nvPr/>
        </p:nvSpPr>
        <p:spPr>
          <a:xfrm>
            <a:off x="3933056" y="776536"/>
            <a:ext cx="1594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IZ1-RD</a:t>
            </a:r>
          </a:p>
        </p:txBody>
      </p:sp>
      <p:sp>
        <p:nvSpPr>
          <p:cNvPr id="49" name="TextBox 173"/>
          <p:cNvSpPr txBox="1"/>
          <p:nvPr/>
        </p:nvSpPr>
        <p:spPr>
          <a:xfrm>
            <a:off x="1749787" y="776536"/>
            <a:ext cx="14631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IZ1-F</a:t>
            </a:r>
          </a:p>
        </p:txBody>
      </p:sp>
      <p:sp>
        <p:nvSpPr>
          <p:cNvPr id="53" name="TextBox 173"/>
          <p:cNvSpPr txBox="1"/>
          <p:nvPr/>
        </p:nvSpPr>
        <p:spPr>
          <a:xfrm>
            <a:off x="1683219" y="3326433"/>
            <a:ext cx="1714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IZ1-F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960885" y="3419927"/>
            <a:ext cx="4921514" cy="1594629"/>
            <a:chOff x="960885" y="3419927"/>
            <a:chExt cx="4921514" cy="1594629"/>
          </a:xfrm>
        </p:grpSpPr>
        <p:sp>
          <p:nvSpPr>
            <p:cNvPr id="28" name="TextBox 156"/>
            <p:cNvSpPr txBox="1"/>
            <p:nvPr/>
          </p:nvSpPr>
          <p:spPr>
            <a:xfrm rot="16200000">
              <a:off x="443763" y="3976537"/>
              <a:ext cx="13112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Urinary bladder</a:t>
              </a:r>
            </a:p>
          </p:txBody>
        </p:sp>
        <p:grpSp>
          <p:nvGrpSpPr>
            <p:cNvPr id="6" name="Groep 5"/>
            <p:cNvGrpSpPr/>
            <p:nvPr/>
          </p:nvGrpSpPr>
          <p:grpSpPr>
            <a:xfrm>
              <a:off x="3504687" y="3440832"/>
              <a:ext cx="2377712" cy="1573724"/>
              <a:chOff x="367209" y="5977954"/>
              <a:chExt cx="2377712" cy="1573724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22549" y="6139212"/>
                <a:ext cx="1800000" cy="107952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1" name="TextBox 198"/>
              <p:cNvSpPr txBox="1"/>
              <p:nvPr/>
            </p:nvSpPr>
            <p:spPr>
              <a:xfrm>
                <a:off x="620686" y="7151568"/>
                <a:ext cx="212423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normal    I        II       III      IV</a:t>
                </a:r>
              </a:p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(n=3) (n=1) (n=5) (n=10) (n=5)</a:t>
                </a:r>
              </a:p>
            </p:txBody>
          </p:sp>
          <p:sp>
            <p:nvSpPr>
              <p:cNvPr id="64" name="TextBox 178"/>
              <p:cNvSpPr txBox="1"/>
              <p:nvPr/>
            </p:nvSpPr>
            <p:spPr>
              <a:xfrm>
                <a:off x="367209" y="5977954"/>
                <a:ext cx="432048" cy="13080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  <a:p>
                <a:pPr algn="r"/>
                <a:endParaRPr lang="en-GB" sz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GB" sz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1262392" y="3419927"/>
              <a:ext cx="2387759" cy="1573143"/>
              <a:chOff x="1262392" y="3419927"/>
              <a:chExt cx="2387759" cy="1573143"/>
            </a:xfrm>
          </p:grpSpPr>
          <p:grpSp>
            <p:nvGrpSpPr>
              <p:cNvPr id="5" name="Groep 4"/>
              <p:cNvGrpSpPr/>
              <p:nvPr/>
            </p:nvGrpSpPr>
            <p:grpSpPr>
              <a:xfrm>
                <a:off x="1262392" y="3419927"/>
                <a:ext cx="2135732" cy="1292662"/>
                <a:chOff x="548680" y="4509919"/>
                <a:chExt cx="2135732" cy="1292662"/>
              </a:xfrm>
            </p:grpSpPr>
            <p:pic>
              <p:nvPicPr>
                <p:cNvPr id="32" name="Picture 9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84412" y="4689119"/>
                  <a:ext cx="1800000" cy="10827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3" name="TextBox 170"/>
                <p:cNvSpPr txBox="1"/>
                <p:nvPr/>
              </p:nvSpPr>
              <p:spPr>
                <a:xfrm>
                  <a:off x="548680" y="4509919"/>
                  <a:ext cx="432048" cy="12926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Q</a:t>
                  </a:r>
                </a:p>
                <a:p>
                  <a:pPr algn="r"/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3</a:t>
                  </a:r>
                </a:p>
                <a:p>
                  <a:pPr algn="r"/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</a:p>
                <a:p>
                  <a:pPr algn="r"/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</a:p>
                <a:p>
                  <a:pPr algn="r"/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</p:grpSp>
          <p:sp>
            <p:nvSpPr>
              <p:cNvPr id="65" name="TextBox 198"/>
              <p:cNvSpPr txBox="1"/>
              <p:nvPr/>
            </p:nvSpPr>
            <p:spPr>
              <a:xfrm>
                <a:off x="1525916" y="4592960"/>
                <a:ext cx="212423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   I        II       III      IV</a:t>
                </a:r>
              </a:p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3) (n=1) (n=5) (n=10) (n=5)</a:t>
                </a:r>
              </a:p>
            </p:txBody>
          </p:sp>
        </p:grpSp>
      </p:grpSp>
      <p:sp>
        <p:nvSpPr>
          <p:cNvPr id="59" name="TextBox 172"/>
          <p:cNvSpPr txBox="1"/>
          <p:nvPr/>
        </p:nvSpPr>
        <p:spPr>
          <a:xfrm>
            <a:off x="3933056" y="3326433"/>
            <a:ext cx="1594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IZ1-RD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960887" y="5167570"/>
            <a:ext cx="4885509" cy="1729646"/>
            <a:chOff x="960887" y="5167570"/>
            <a:chExt cx="4885509" cy="1729646"/>
          </a:xfrm>
        </p:grpSpPr>
        <p:sp>
          <p:nvSpPr>
            <p:cNvPr id="20" name="TextBox 157"/>
            <p:cNvSpPr txBox="1"/>
            <p:nvPr/>
          </p:nvSpPr>
          <p:spPr>
            <a:xfrm rot="16200000">
              <a:off x="510112" y="5769331"/>
              <a:ext cx="11785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Stomach</a:t>
              </a:r>
            </a:p>
          </p:txBody>
        </p:sp>
        <p:grpSp>
          <p:nvGrpSpPr>
            <p:cNvPr id="17" name="Groep 16"/>
            <p:cNvGrpSpPr/>
            <p:nvPr/>
          </p:nvGrpSpPr>
          <p:grpSpPr>
            <a:xfrm>
              <a:off x="1296070" y="5167570"/>
              <a:ext cx="4550326" cy="1729646"/>
              <a:chOff x="462850" y="4056092"/>
              <a:chExt cx="4550326" cy="1729646"/>
            </a:xfrm>
          </p:grpSpPr>
          <p:grpSp>
            <p:nvGrpSpPr>
              <p:cNvPr id="37" name="Groep 36"/>
              <p:cNvGrpSpPr/>
              <p:nvPr/>
            </p:nvGrpSpPr>
            <p:grpSpPr>
              <a:xfrm>
                <a:off x="2708920" y="4191109"/>
                <a:ext cx="2304256" cy="1594629"/>
                <a:chOff x="2204864" y="5990729"/>
                <a:chExt cx="2304256" cy="1594629"/>
              </a:xfrm>
            </p:grpSpPr>
            <p:pic>
              <p:nvPicPr>
                <p:cNvPr id="26" name="Picture 10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54649" y="6157219"/>
                  <a:ext cx="1800000" cy="108079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7" name="TextBox 178"/>
                <p:cNvSpPr txBox="1"/>
                <p:nvPr/>
              </p:nvSpPr>
              <p:spPr>
                <a:xfrm>
                  <a:off x="2204864" y="5990729"/>
                  <a:ext cx="432048" cy="13696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Q</a:t>
                  </a:r>
                </a:p>
                <a:p>
                  <a:pPr algn="r"/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  <a:p>
                  <a:pPr algn="r"/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  <a:p>
                  <a:pPr algn="r"/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n-GB" sz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 algn="r"/>
                  <a:endParaRPr lang="en-GB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n-GB" sz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23" name="TextBox 201"/>
                <p:cNvSpPr txBox="1"/>
                <p:nvPr/>
              </p:nvSpPr>
              <p:spPr>
                <a:xfrm>
                  <a:off x="2535956" y="7185248"/>
                  <a:ext cx="197316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      I          II         NR</a:t>
                  </a:r>
                </a:p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n=4)    (n=3)   (n=3)    (n=7)</a:t>
                  </a:r>
                </a:p>
              </p:txBody>
            </p:sp>
          </p:grpSp>
          <p:grpSp>
            <p:nvGrpSpPr>
              <p:cNvPr id="13" name="Groep 12"/>
              <p:cNvGrpSpPr/>
              <p:nvPr/>
            </p:nvGrpSpPr>
            <p:grpSpPr>
              <a:xfrm>
                <a:off x="462850" y="4056092"/>
                <a:ext cx="2275018" cy="1729066"/>
                <a:chOff x="462850" y="4056092"/>
                <a:chExt cx="2275018" cy="1729066"/>
              </a:xfrm>
            </p:grpSpPr>
            <p:grpSp>
              <p:nvGrpSpPr>
                <p:cNvPr id="7" name="Groep 6"/>
                <p:cNvGrpSpPr/>
                <p:nvPr/>
              </p:nvGrpSpPr>
              <p:grpSpPr>
                <a:xfrm>
                  <a:off x="462850" y="4056092"/>
                  <a:ext cx="2102054" cy="1431161"/>
                  <a:chOff x="2382358" y="4513964"/>
                  <a:chExt cx="2102054" cy="1431161"/>
                </a:xfrm>
              </p:grpSpPr>
              <p:pic>
                <p:nvPicPr>
                  <p:cNvPr id="1027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684412" y="4808984"/>
                    <a:ext cx="1800000" cy="107952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1" name="TextBox 170"/>
                  <p:cNvSpPr txBox="1"/>
                  <p:nvPr/>
                </p:nvSpPr>
                <p:spPr>
                  <a:xfrm>
                    <a:off x="2382358" y="4513964"/>
                    <a:ext cx="432048" cy="143116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endParaRPr lang="en-GB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Q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3</a:t>
                    </a:r>
                  </a:p>
                  <a:p>
                    <a:pPr algn="r"/>
                    <a:endParaRPr lang="en-GB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GB" sz="5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2</a:t>
                    </a:r>
                  </a:p>
                  <a:p>
                    <a:pPr algn="r"/>
                    <a:endParaRPr lang="en-GB" sz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GB" sz="5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1</a:t>
                    </a:r>
                  </a:p>
                  <a:p>
                    <a:pPr algn="r"/>
                    <a:endParaRPr lang="en-GB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</p:grpSp>
            <p:sp>
              <p:nvSpPr>
                <p:cNvPr id="67" name="TextBox 201"/>
                <p:cNvSpPr txBox="1"/>
                <p:nvPr/>
              </p:nvSpPr>
              <p:spPr>
                <a:xfrm>
                  <a:off x="764704" y="5385048"/>
                  <a:ext cx="197316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     I           II        NR</a:t>
                  </a:r>
                </a:p>
                <a:p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n=3)   (n=3)    (n=3)   (n=6)</a:t>
                  </a:r>
                </a:p>
              </p:txBody>
            </p:sp>
          </p:grpSp>
        </p:grpSp>
        <p:sp>
          <p:nvSpPr>
            <p:cNvPr id="56" name="TextBox 173"/>
            <p:cNvSpPr txBox="1"/>
            <p:nvPr/>
          </p:nvSpPr>
          <p:spPr>
            <a:xfrm>
              <a:off x="1683219" y="5252065"/>
              <a:ext cx="18160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IZ1-F</a:t>
              </a:r>
            </a:p>
          </p:txBody>
        </p:sp>
        <p:sp>
          <p:nvSpPr>
            <p:cNvPr id="60" name="TextBox 172"/>
            <p:cNvSpPr txBox="1"/>
            <p:nvPr/>
          </p:nvSpPr>
          <p:spPr>
            <a:xfrm>
              <a:off x="3933056" y="5241032"/>
              <a:ext cx="1594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IZ1-RD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960886" y="6969224"/>
            <a:ext cx="4914458" cy="1800200"/>
            <a:chOff x="960886" y="6897216"/>
            <a:chExt cx="4914458" cy="1800200"/>
          </a:xfrm>
        </p:grpSpPr>
        <p:sp>
          <p:nvSpPr>
            <p:cNvPr id="12" name="TextBox 158"/>
            <p:cNvSpPr txBox="1"/>
            <p:nvPr/>
          </p:nvSpPr>
          <p:spPr>
            <a:xfrm rot="16200000">
              <a:off x="524224" y="7478824"/>
              <a:ext cx="11503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Thyroid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266832" y="6897216"/>
              <a:ext cx="4608512" cy="1800200"/>
              <a:chOff x="1266832" y="6897216"/>
              <a:chExt cx="4608512" cy="1800200"/>
            </a:xfrm>
          </p:grpSpPr>
          <p:grpSp>
            <p:nvGrpSpPr>
              <p:cNvPr id="16" name="Groep 15"/>
              <p:cNvGrpSpPr/>
              <p:nvPr/>
            </p:nvGrpSpPr>
            <p:grpSpPr>
              <a:xfrm>
                <a:off x="1266832" y="6936993"/>
                <a:ext cx="4608512" cy="1760423"/>
                <a:chOff x="433612" y="5547355"/>
                <a:chExt cx="4608512" cy="1760423"/>
              </a:xfrm>
            </p:grpSpPr>
            <p:grpSp>
              <p:nvGrpSpPr>
                <p:cNvPr id="38" name="Groep 37"/>
                <p:cNvGrpSpPr/>
                <p:nvPr/>
              </p:nvGrpSpPr>
              <p:grpSpPr>
                <a:xfrm>
                  <a:off x="2708920" y="5547355"/>
                  <a:ext cx="2333204" cy="1760423"/>
                  <a:chOff x="4437112" y="6050831"/>
                  <a:chExt cx="2333204" cy="1760423"/>
                </a:xfrm>
              </p:grpSpPr>
              <p:pic>
                <p:nvPicPr>
                  <p:cNvPr id="1028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747979" y="6212526"/>
                    <a:ext cx="1800000" cy="107762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5" name="TextBox 200"/>
                  <p:cNvSpPr txBox="1"/>
                  <p:nvPr/>
                </p:nvSpPr>
                <p:spPr>
                  <a:xfrm>
                    <a:off x="4725144" y="7257256"/>
                    <a:ext cx="2045172" cy="5539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   I        II      III       IV</a:t>
                    </a:r>
                  </a:p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n=3) (n=9) (n=2) (n=5) (n=1)</a:t>
                    </a:r>
                  </a:p>
                  <a:p>
                    <a:endParaRPr lang="en-GB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TextBox 178"/>
                  <p:cNvSpPr txBox="1"/>
                  <p:nvPr/>
                </p:nvSpPr>
                <p:spPr>
                  <a:xfrm>
                    <a:off x="4437112" y="6050831"/>
                    <a:ext cx="432048" cy="13080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Q</a:t>
                    </a:r>
                  </a:p>
                  <a:p>
                    <a:pPr algn="r"/>
                    <a:endParaRPr lang="en-GB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0</a:t>
                    </a:r>
                  </a:p>
                  <a:p>
                    <a:pPr algn="r"/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</a:t>
                    </a:r>
                  </a:p>
                  <a:p>
                    <a:pPr algn="r"/>
                    <a:endParaRPr lang="en-GB" sz="5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GB" sz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0</a:t>
                    </a:r>
                  </a:p>
                  <a:p>
                    <a:pPr algn="r"/>
                    <a:endParaRPr lang="en-GB" sz="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endParaRPr lang="en-GB" sz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 algn="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0</a:t>
                    </a:r>
                  </a:p>
                </p:txBody>
              </p:sp>
            </p:grpSp>
            <p:grpSp>
              <p:nvGrpSpPr>
                <p:cNvPr id="11" name="Groep 10"/>
                <p:cNvGrpSpPr/>
                <p:nvPr/>
              </p:nvGrpSpPr>
              <p:grpSpPr>
                <a:xfrm>
                  <a:off x="433612" y="5559261"/>
                  <a:ext cx="2275308" cy="1594629"/>
                  <a:chOff x="433612" y="5559261"/>
                  <a:chExt cx="2275308" cy="1594629"/>
                </a:xfrm>
              </p:grpSpPr>
              <p:grpSp>
                <p:nvGrpSpPr>
                  <p:cNvPr id="8" name="Groep 7"/>
                  <p:cNvGrpSpPr/>
                  <p:nvPr/>
                </p:nvGrpSpPr>
                <p:grpSpPr>
                  <a:xfrm>
                    <a:off x="433612" y="5559261"/>
                    <a:ext cx="2131292" cy="1323439"/>
                    <a:chOff x="4321844" y="4418581"/>
                    <a:chExt cx="2131292" cy="1323439"/>
                  </a:xfrm>
                </p:grpSpPr>
                <p:pic>
                  <p:nvPicPr>
                    <p:cNvPr id="1029" name="Picture 5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653136" y="4582642"/>
                      <a:ext cx="1800000" cy="107952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62" name="TextBox 170"/>
                    <p:cNvSpPr txBox="1"/>
                    <p:nvPr/>
                  </p:nvSpPr>
                  <p:spPr>
                    <a:xfrm>
                      <a:off x="4321844" y="4418581"/>
                      <a:ext cx="432048" cy="132343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Q</a:t>
                      </a:r>
                    </a:p>
                    <a:p>
                      <a:pPr algn="r"/>
                      <a:endParaRPr lang="en-GB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  <a:p>
                      <a:pPr algn="r"/>
                      <a:endParaRPr lang="en-GB" sz="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GB" sz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  <a:p>
                      <a:pPr algn="r"/>
                      <a:endParaRPr lang="en-GB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endParaRPr lang="en-GB" sz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  <a:p>
                      <a:pPr algn="r"/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r"/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</a:p>
                  </p:txBody>
                </p:sp>
              </p:grpSp>
              <p:sp>
                <p:nvSpPr>
                  <p:cNvPr id="69" name="TextBox 200"/>
                  <p:cNvSpPr txBox="1"/>
                  <p:nvPr/>
                </p:nvSpPr>
                <p:spPr>
                  <a:xfrm>
                    <a:off x="738000" y="6753780"/>
                    <a:ext cx="1970920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   I        II       III      IV</a:t>
                    </a:r>
                  </a:p>
                  <a:p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n=1) (n=9) (n=2) (n=5) (n=1)</a:t>
                    </a:r>
                  </a:p>
                </p:txBody>
              </p:sp>
            </p:grpSp>
          </p:grpSp>
          <p:sp>
            <p:nvSpPr>
              <p:cNvPr id="58" name="TextBox 173"/>
              <p:cNvSpPr txBox="1"/>
              <p:nvPr/>
            </p:nvSpPr>
            <p:spPr>
              <a:xfrm>
                <a:off x="1683219" y="6897216"/>
                <a:ext cx="17149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IZ1-F</a:t>
                </a:r>
              </a:p>
            </p:txBody>
          </p:sp>
          <p:sp>
            <p:nvSpPr>
              <p:cNvPr id="68" name="TextBox 172"/>
              <p:cNvSpPr txBox="1"/>
              <p:nvPr/>
            </p:nvSpPr>
            <p:spPr>
              <a:xfrm>
                <a:off x="3933056" y="6926833"/>
                <a:ext cx="16555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>
                    <a:latin typeface="Arial" panose="020B0604020202020204" pitchFamily="34" charset="0"/>
                    <a:cs typeface="Arial" panose="020B0604020202020204" pitchFamily="34" charset="0"/>
                  </a:rPr>
                  <a:t>CIZ1-RD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2" name="Group 51"/>
          <p:cNvGrpSpPr/>
          <p:nvPr/>
        </p:nvGrpSpPr>
        <p:grpSpPr>
          <a:xfrm>
            <a:off x="3535993" y="1125543"/>
            <a:ext cx="2052568" cy="1696834"/>
            <a:chOff x="3535993" y="1125543"/>
            <a:chExt cx="2052568" cy="1696834"/>
          </a:xfrm>
        </p:grpSpPr>
        <p:pic>
          <p:nvPicPr>
            <p:cNvPr id="46" name="Picture 16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88561" y="1434972"/>
              <a:ext cx="1800000" cy="10776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" name="TextBox 190"/>
            <p:cNvSpPr txBox="1"/>
            <p:nvPr/>
          </p:nvSpPr>
          <p:spPr>
            <a:xfrm>
              <a:off x="3535993" y="1125543"/>
              <a:ext cx="447520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Q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  <a:p>
              <a:pPr algn="r"/>
              <a:endParaRPr lang="en-GB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39" name="TextBox 196"/>
            <p:cNvSpPr txBox="1"/>
            <p:nvPr/>
          </p:nvSpPr>
          <p:spPr>
            <a:xfrm>
              <a:off x="3882700" y="2422267"/>
              <a:ext cx="170586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normal    I          II        III</a:t>
              </a:r>
            </a:p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(n=24)  (n=8) (n=10) (n=6)</a:t>
              </a:r>
            </a:p>
          </p:txBody>
        </p:sp>
        <p:grpSp>
          <p:nvGrpSpPr>
            <p:cNvPr id="141" name="Group 140"/>
            <p:cNvGrpSpPr/>
            <p:nvPr/>
          </p:nvGrpSpPr>
          <p:grpSpPr>
            <a:xfrm>
              <a:off x="4025436" y="1125543"/>
              <a:ext cx="915732" cy="803121"/>
              <a:chOff x="1157220" y="682423"/>
              <a:chExt cx="915732" cy="803121"/>
            </a:xfrm>
          </p:grpSpPr>
          <p:grpSp>
            <p:nvGrpSpPr>
              <p:cNvPr id="142" name="Group 141"/>
              <p:cNvGrpSpPr/>
              <p:nvPr/>
            </p:nvGrpSpPr>
            <p:grpSpPr>
              <a:xfrm>
                <a:off x="1258078" y="682423"/>
                <a:ext cx="814874" cy="803121"/>
                <a:chOff x="112983" y="884220"/>
                <a:chExt cx="814874" cy="803121"/>
              </a:xfrm>
            </p:grpSpPr>
            <p:grpSp>
              <p:nvGrpSpPr>
                <p:cNvPr id="144" name="Group 143"/>
                <p:cNvGrpSpPr/>
                <p:nvPr/>
              </p:nvGrpSpPr>
              <p:grpSpPr>
                <a:xfrm>
                  <a:off x="112983" y="884220"/>
                  <a:ext cx="626400" cy="803121"/>
                  <a:chOff x="23283697" y="26134528"/>
                  <a:chExt cx="626400" cy="803121"/>
                </a:xfrm>
              </p:grpSpPr>
              <p:grpSp>
                <p:nvGrpSpPr>
                  <p:cNvPr id="146" name="Group 145"/>
                  <p:cNvGrpSpPr/>
                  <p:nvPr/>
                </p:nvGrpSpPr>
                <p:grpSpPr>
                  <a:xfrm>
                    <a:off x="23283697" y="26350551"/>
                    <a:ext cx="626400" cy="587098"/>
                    <a:chOff x="23283697" y="26350551"/>
                    <a:chExt cx="626400" cy="587098"/>
                  </a:xfrm>
                </p:grpSpPr>
                <p:cxnSp>
                  <p:nvCxnSpPr>
                    <p:cNvPr id="148" name="Straight Connector 147"/>
                    <p:cNvCxnSpPr/>
                    <p:nvPr/>
                  </p:nvCxnSpPr>
                  <p:spPr bwMode="auto">
                    <a:xfrm flipV="1">
                      <a:off x="23290851" y="26353793"/>
                      <a:ext cx="0" cy="583856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cxnSp>
                  <p:nvCxnSpPr>
                    <p:cNvPr id="149" name="Straight Connector 148"/>
                    <p:cNvCxnSpPr/>
                    <p:nvPr/>
                  </p:nvCxnSpPr>
                  <p:spPr bwMode="auto">
                    <a:xfrm flipV="1">
                      <a:off x="23909403" y="26350551"/>
                      <a:ext cx="0" cy="154800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cxnSp>
                  <p:nvCxnSpPr>
                    <p:cNvPr id="150" name="Straight Connector 149"/>
                    <p:cNvCxnSpPr/>
                    <p:nvPr/>
                  </p:nvCxnSpPr>
                  <p:spPr bwMode="auto">
                    <a:xfrm flipV="1">
                      <a:off x="23283697" y="26361585"/>
                      <a:ext cx="626400" cy="0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</p:grpSp>
              <p:sp>
                <p:nvSpPr>
                  <p:cNvPr id="147" name="TextBox 146"/>
                  <p:cNvSpPr txBox="1"/>
                  <p:nvPr/>
                </p:nvSpPr>
                <p:spPr>
                  <a:xfrm>
                    <a:off x="23291546" y="26134528"/>
                    <a:ext cx="59612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S</a:t>
                    </a:r>
                  </a:p>
                </p:txBody>
              </p:sp>
            </p:grpSp>
            <p:cxnSp>
              <p:nvCxnSpPr>
                <p:cNvPr id="145" name="Straight Connector 144"/>
                <p:cNvCxnSpPr/>
                <p:nvPr/>
              </p:nvCxnSpPr>
              <p:spPr bwMode="auto">
                <a:xfrm>
                  <a:off x="490368" y="1261603"/>
                  <a:ext cx="437489" cy="0"/>
                </a:xfrm>
                <a:prstGeom prst="line">
                  <a:avLst/>
                </a:prstGeom>
                <a:solidFill>
                  <a:schemeClr val="accent1"/>
                </a:solidFill>
                <a:ln w="1587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43" name="Straight Connector 142"/>
              <p:cNvCxnSpPr/>
              <p:nvPr/>
            </p:nvCxnSpPr>
            <p:spPr bwMode="auto">
              <a:xfrm>
                <a:off x="1157220" y="1485544"/>
                <a:ext cx="216024" cy="0"/>
              </a:xfrm>
              <a:prstGeom prst="line">
                <a:avLst/>
              </a:prstGeom>
              <a:solidFill>
                <a:schemeClr val="accent1"/>
              </a:solidFill>
              <a:ln w="158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</p:grpSp>
      <p:grpSp>
        <p:nvGrpSpPr>
          <p:cNvPr id="45" name="Group 44"/>
          <p:cNvGrpSpPr/>
          <p:nvPr/>
        </p:nvGrpSpPr>
        <p:grpSpPr>
          <a:xfrm>
            <a:off x="1256614" y="1125543"/>
            <a:ext cx="2027084" cy="1693352"/>
            <a:chOff x="1256614" y="1125543"/>
            <a:chExt cx="2027084" cy="1693352"/>
          </a:xfrm>
        </p:grpSpPr>
        <p:pic>
          <p:nvPicPr>
            <p:cNvPr id="42" name="Picture 1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54108" y="1413575"/>
              <a:ext cx="1800000" cy="10795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TextBox 189"/>
            <p:cNvSpPr txBox="1"/>
            <p:nvPr/>
          </p:nvSpPr>
          <p:spPr>
            <a:xfrm>
              <a:off x="1256614" y="1125543"/>
              <a:ext cx="432048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Q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/>
              <a:endParaRPr lang="en-GB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57" name="TextBox 196"/>
            <p:cNvSpPr txBox="1"/>
            <p:nvPr/>
          </p:nvSpPr>
          <p:spPr>
            <a:xfrm>
              <a:off x="1525916" y="2418785"/>
              <a:ext cx="17577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normal     I         II         III</a:t>
              </a:r>
            </a:p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(n=24) (n=8)  (n=10)  (n=6)</a:t>
              </a:r>
            </a:p>
          </p:txBody>
        </p:sp>
        <p:grpSp>
          <p:nvGrpSpPr>
            <p:cNvPr id="158" name="Group 157"/>
            <p:cNvGrpSpPr/>
            <p:nvPr/>
          </p:nvGrpSpPr>
          <p:grpSpPr>
            <a:xfrm>
              <a:off x="1693654" y="1136576"/>
              <a:ext cx="922886" cy="1008112"/>
              <a:chOff x="1150066" y="729703"/>
              <a:chExt cx="922886" cy="1008112"/>
            </a:xfrm>
          </p:grpSpPr>
          <p:grpSp>
            <p:nvGrpSpPr>
              <p:cNvPr id="159" name="Group 158"/>
              <p:cNvGrpSpPr/>
              <p:nvPr/>
            </p:nvGrpSpPr>
            <p:grpSpPr>
              <a:xfrm>
                <a:off x="1258078" y="729703"/>
                <a:ext cx="814874" cy="1008112"/>
                <a:chOff x="112983" y="931500"/>
                <a:chExt cx="814874" cy="1008112"/>
              </a:xfrm>
            </p:grpSpPr>
            <p:grpSp>
              <p:nvGrpSpPr>
                <p:cNvPr id="161" name="Group 160"/>
                <p:cNvGrpSpPr/>
                <p:nvPr/>
              </p:nvGrpSpPr>
              <p:grpSpPr>
                <a:xfrm>
                  <a:off x="112983" y="931500"/>
                  <a:ext cx="626400" cy="1008112"/>
                  <a:chOff x="23283697" y="26181808"/>
                  <a:chExt cx="626400" cy="1008112"/>
                </a:xfrm>
              </p:grpSpPr>
              <p:grpSp>
                <p:nvGrpSpPr>
                  <p:cNvPr id="163" name="Group 162"/>
                  <p:cNvGrpSpPr/>
                  <p:nvPr/>
                </p:nvGrpSpPr>
                <p:grpSpPr>
                  <a:xfrm>
                    <a:off x="23283697" y="26350551"/>
                    <a:ext cx="626400" cy="839369"/>
                    <a:chOff x="23283697" y="26350551"/>
                    <a:chExt cx="626400" cy="839369"/>
                  </a:xfrm>
                </p:grpSpPr>
                <p:cxnSp>
                  <p:nvCxnSpPr>
                    <p:cNvPr id="165" name="Straight Connector 164"/>
                    <p:cNvCxnSpPr/>
                    <p:nvPr/>
                  </p:nvCxnSpPr>
                  <p:spPr bwMode="auto">
                    <a:xfrm flipV="1">
                      <a:off x="23283697" y="26353793"/>
                      <a:ext cx="7154" cy="836127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cxnSp>
                  <p:nvCxnSpPr>
                    <p:cNvPr id="166" name="Straight Connector 165"/>
                    <p:cNvCxnSpPr/>
                    <p:nvPr/>
                  </p:nvCxnSpPr>
                  <p:spPr bwMode="auto">
                    <a:xfrm flipV="1">
                      <a:off x="23909403" y="26350551"/>
                      <a:ext cx="0" cy="154800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  <p:cxnSp>
                  <p:nvCxnSpPr>
                    <p:cNvPr id="167" name="Straight Connector 166"/>
                    <p:cNvCxnSpPr/>
                    <p:nvPr/>
                  </p:nvCxnSpPr>
                  <p:spPr bwMode="auto">
                    <a:xfrm flipV="1">
                      <a:off x="23283697" y="26361585"/>
                      <a:ext cx="626400" cy="0"/>
                    </a:xfrm>
                    <a:prstGeom prst="line">
                      <a:avLst/>
                    </a:prstGeom>
                    <a:solidFill>
                      <a:schemeClr val="accent1"/>
                    </a:solidFill>
                    <a:ln w="158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  <a:effectLst/>
                  </p:spPr>
                </p:cxnSp>
              </p:grpSp>
              <p:sp>
                <p:nvSpPr>
                  <p:cNvPr id="164" name="TextBox 163"/>
                  <p:cNvSpPr txBox="1"/>
                  <p:nvPr/>
                </p:nvSpPr>
                <p:spPr>
                  <a:xfrm>
                    <a:off x="23291546" y="26181808"/>
                    <a:ext cx="596128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</a:p>
                </p:txBody>
              </p:sp>
            </p:grpSp>
            <p:cxnSp>
              <p:nvCxnSpPr>
                <p:cNvPr id="162" name="Straight Connector 161"/>
                <p:cNvCxnSpPr/>
                <p:nvPr/>
              </p:nvCxnSpPr>
              <p:spPr bwMode="auto">
                <a:xfrm>
                  <a:off x="490368" y="1261603"/>
                  <a:ext cx="437489" cy="0"/>
                </a:xfrm>
                <a:prstGeom prst="line">
                  <a:avLst/>
                </a:prstGeom>
                <a:solidFill>
                  <a:schemeClr val="accent1"/>
                </a:solidFill>
                <a:ln w="1587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</p:grpSp>
          <p:cxnSp>
            <p:nvCxnSpPr>
              <p:cNvPr id="160" name="Straight Connector 159"/>
              <p:cNvCxnSpPr/>
              <p:nvPr/>
            </p:nvCxnSpPr>
            <p:spPr bwMode="auto">
              <a:xfrm>
                <a:off x="1150066" y="1737815"/>
                <a:ext cx="216024" cy="0"/>
              </a:xfrm>
              <a:prstGeom prst="line">
                <a:avLst/>
              </a:prstGeom>
              <a:solidFill>
                <a:schemeClr val="accent1"/>
              </a:solidFill>
              <a:ln w="158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</p:grpSp>
    </p:spTree>
    <p:extLst>
      <p:ext uri="{BB962C8B-B14F-4D97-AF65-F5344CB8AC3E}">
        <p14:creationId xmlns:p14="http://schemas.microsoft.com/office/powerpoint/2010/main" val="4288930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>
            <a:extLst>
              <a:ext uri="{FF2B5EF4-FFF2-40B4-BE49-F238E27FC236}">
                <a16:creationId xmlns:a16="http://schemas.microsoft.com/office/drawing/2014/main" id="{088BE9E7-05B9-4E9B-A9C5-7FC33C2CA4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328" y="128464"/>
            <a:ext cx="6525344" cy="2677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 </a:t>
            </a:r>
            <a:r>
              <a:rPr kumimoji="0" lang="en-GB" altLang="en-US" sz="12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 expression in other cancers.</a:t>
            </a:r>
            <a:endParaRPr kumimoji="0" lang="en-GB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Mean expression levels of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 (red),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D (grey), in normal lung tissue and lung tumour samples grouped by stage. The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 data for individual samples (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igene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ung cancer Tissue Scan cDNA array HLRT504). RQ values are relative to the mean of RD in the normal samples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t differences are indicated (NS, not significant; Related-Samples Wilcoxon Signed Rank Test).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e was a significant difference between normal samples and early stage cancers (I and II) for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 but not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D.</a:t>
            </a:r>
            <a:endParaRPr kumimoji="0" lang="en-GB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F (red) and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D (grey) expression levels in urinary bladder, stomach and thyroid cancer samples, compared to normal bladder, stomach and thyroid tissue in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igene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NA array CSRT103 (sample-specific information and pathology reports can be found at </a:t>
            </a:r>
            <a:r>
              <a:rPr kumimoji="0" lang="en-GB" altLang="en-US" sz="1200" b="0" i="0" u="sng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origene.com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RQ is expressed relative to the mean 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Z1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D levels of the normal samples for each cancer type. White bars indicate that only one sample was available within a category. NR, not reported. Primers and probes are listed in 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cept for the lung array CIZ1-F data, which have been described previously.</a:t>
            </a:r>
            <a:r>
              <a:rPr kumimoji="0" lang="en-GB" altLang="en-US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4636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17</TotalTime>
  <Words>506</Words>
  <Application>Microsoft Office PowerPoint</Application>
  <PresentationFormat>A4 Paper (210x297 mm)</PresentationFormat>
  <Paragraphs>1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he University of Yo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Swarts</cp:lastModifiedBy>
  <cp:revision>849</cp:revision>
  <cp:lastPrinted>2016-03-07T16:44:20Z</cp:lastPrinted>
  <dcterms:created xsi:type="dcterms:W3CDTF">2014-11-24T16:22:39Z</dcterms:created>
  <dcterms:modified xsi:type="dcterms:W3CDTF">2018-08-29T21:22:56Z</dcterms:modified>
</cp:coreProperties>
</file>